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6" r:id="rId3"/>
    <p:sldId id="267" r:id="rId4"/>
    <p:sldId id="268" r:id="rId5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218" y="1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atih Karadeniz" userId="bbf405710e62e9f7" providerId="LiveId" clId="{E597BBBC-1D10-4755-96F1-2105B9D46A83}"/>
    <pc:docChg chg="modSld">
      <pc:chgData name="Fatih Karadeniz" userId="bbf405710e62e9f7" providerId="LiveId" clId="{E597BBBC-1D10-4755-96F1-2105B9D46A83}" dt="2019-02-07T03:55:48.627" v="27" actId="20577"/>
      <pc:docMkLst>
        <pc:docMk/>
      </pc:docMkLst>
      <pc:sldChg chg="modSp">
        <pc:chgData name="Fatih Karadeniz" userId="bbf405710e62e9f7" providerId="LiveId" clId="{E597BBBC-1D10-4755-96F1-2105B9D46A83}" dt="2019-02-07T03:53:57.309" v="6" actId="20577"/>
        <pc:sldMkLst>
          <pc:docMk/>
          <pc:sldMk cId="2902254072" sldId="265"/>
        </pc:sldMkLst>
        <pc:spChg chg="mod">
          <ac:chgData name="Fatih Karadeniz" userId="bbf405710e62e9f7" providerId="LiveId" clId="{E597BBBC-1D10-4755-96F1-2105B9D46A83}" dt="2019-02-07T03:53:57.309" v="6" actId="20577"/>
          <ac:spMkLst>
            <pc:docMk/>
            <pc:sldMk cId="2902254072" sldId="265"/>
            <ac:spMk id="5" creationId="{00000000-0000-0000-0000-000000000000}"/>
          </ac:spMkLst>
        </pc:spChg>
      </pc:sldChg>
      <pc:sldChg chg="modSp">
        <pc:chgData name="Fatih Karadeniz" userId="bbf405710e62e9f7" providerId="LiveId" clId="{E597BBBC-1D10-4755-96F1-2105B9D46A83}" dt="2019-02-07T03:54:57.573" v="13" actId="20577"/>
        <pc:sldMkLst>
          <pc:docMk/>
          <pc:sldMk cId="3661594293" sldId="266"/>
        </pc:sldMkLst>
        <pc:spChg chg="mod">
          <ac:chgData name="Fatih Karadeniz" userId="bbf405710e62e9f7" providerId="LiveId" clId="{E597BBBC-1D10-4755-96F1-2105B9D46A83}" dt="2019-02-07T03:54:57.573" v="13" actId="20577"/>
          <ac:spMkLst>
            <pc:docMk/>
            <pc:sldMk cId="3661594293" sldId="266"/>
            <ac:spMk id="5" creationId="{00000000-0000-0000-0000-000000000000}"/>
          </ac:spMkLst>
        </pc:spChg>
      </pc:sldChg>
      <pc:sldChg chg="modSp">
        <pc:chgData name="Fatih Karadeniz" userId="bbf405710e62e9f7" providerId="LiveId" clId="{E597BBBC-1D10-4755-96F1-2105B9D46A83}" dt="2019-02-07T03:55:27.620" v="20" actId="20577"/>
        <pc:sldMkLst>
          <pc:docMk/>
          <pc:sldMk cId="2031617388" sldId="267"/>
        </pc:sldMkLst>
        <pc:spChg chg="mod">
          <ac:chgData name="Fatih Karadeniz" userId="bbf405710e62e9f7" providerId="LiveId" clId="{E597BBBC-1D10-4755-96F1-2105B9D46A83}" dt="2019-02-07T03:55:27.620" v="20" actId="20577"/>
          <ac:spMkLst>
            <pc:docMk/>
            <pc:sldMk cId="2031617388" sldId="267"/>
            <ac:spMk id="5" creationId="{00000000-0000-0000-0000-000000000000}"/>
          </ac:spMkLst>
        </pc:spChg>
      </pc:sldChg>
      <pc:sldChg chg="modSp">
        <pc:chgData name="Fatih Karadeniz" userId="bbf405710e62e9f7" providerId="LiveId" clId="{E597BBBC-1D10-4755-96F1-2105B9D46A83}" dt="2019-02-07T03:55:48.627" v="27" actId="20577"/>
        <pc:sldMkLst>
          <pc:docMk/>
          <pc:sldMk cId="2549017636" sldId="268"/>
        </pc:sldMkLst>
        <pc:spChg chg="mod">
          <ac:chgData name="Fatih Karadeniz" userId="bbf405710e62e9f7" providerId="LiveId" clId="{E597BBBC-1D10-4755-96F1-2105B9D46A83}" dt="2019-02-07T03:55:48.627" v="27" actId="20577"/>
          <ac:spMkLst>
            <pc:docMk/>
            <pc:sldMk cId="2549017636" sldId="268"/>
            <ac:spMk id="5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74B54-4268-41E5-A3D2-659CAEE18298}" type="datetimeFigureOut">
              <a:rPr lang="ko-KR" altLang="en-US" smtClean="0"/>
              <a:t>2019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564E2-3C4D-4116-8609-9E614C2A835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74B54-4268-41E5-A3D2-659CAEE18298}" type="datetimeFigureOut">
              <a:rPr lang="ko-KR" altLang="en-US" smtClean="0"/>
              <a:t>2019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564E2-3C4D-4116-8609-9E614C2A835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74B54-4268-41E5-A3D2-659CAEE18298}" type="datetimeFigureOut">
              <a:rPr lang="ko-KR" altLang="en-US" smtClean="0"/>
              <a:t>2019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564E2-3C4D-4116-8609-9E614C2A835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74B54-4268-41E5-A3D2-659CAEE18298}" type="datetimeFigureOut">
              <a:rPr lang="ko-KR" altLang="en-US" smtClean="0"/>
              <a:t>2019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564E2-3C4D-4116-8609-9E614C2A835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74B54-4268-41E5-A3D2-659CAEE18298}" type="datetimeFigureOut">
              <a:rPr lang="ko-KR" altLang="en-US" smtClean="0"/>
              <a:t>2019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564E2-3C4D-4116-8609-9E614C2A835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74B54-4268-41E5-A3D2-659CAEE18298}" type="datetimeFigureOut">
              <a:rPr lang="ko-KR" altLang="en-US" smtClean="0"/>
              <a:t>2019-02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564E2-3C4D-4116-8609-9E614C2A835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74B54-4268-41E5-A3D2-659CAEE18298}" type="datetimeFigureOut">
              <a:rPr lang="ko-KR" altLang="en-US" smtClean="0"/>
              <a:t>2019-02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564E2-3C4D-4116-8609-9E614C2A835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74B54-4268-41E5-A3D2-659CAEE18298}" type="datetimeFigureOut">
              <a:rPr lang="ko-KR" altLang="en-US" smtClean="0"/>
              <a:t>2019-02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564E2-3C4D-4116-8609-9E614C2A835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74B54-4268-41E5-A3D2-659CAEE18298}" type="datetimeFigureOut">
              <a:rPr lang="ko-KR" altLang="en-US" smtClean="0"/>
              <a:t>2019-02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564E2-3C4D-4116-8609-9E614C2A835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74B54-4268-41E5-A3D2-659CAEE18298}" type="datetimeFigureOut">
              <a:rPr lang="ko-KR" altLang="en-US" smtClean="0"/>
              <a:t>2019-02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564E2-3C4D-4116-8609-9E614C2A835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74B54-4268-41E5-A3D2-659CAEE18298}" type="datetimeFigureOut">
              <a:rPr lang="ko-KR" altLang="en-US" smtClean="0"/>
              <a:t>2019-02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564E2-3C4D-4116-8609-9E614C2A835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674B54-4268-41E5-A3D2-659CAEE18298}" type="datetimeFigureOut">
              <a:rPr lang="ko-KR" altLang="en-US" smtClean="0"/>
              <a:t>2019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B564E2-3C4D-4116-8609-9E614C2A835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/>
          <p:cNvSpPr/>
          <p:nvPr/>
        </p:nvSpPr>
        <p:spPr>
          <a:xfrm>
            <a:off x="262936" y="171307"/>
            <a:ext cx="810039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ko-KR" sz="2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 NMR Spectrum of GL-3 (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(MeOH-d</a:t>
            </a:r>
            <a:r>
              <a:rPr lang="en-US" altLang="ko-KR" sz="2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900 MHz)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251520" y="5541045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680" y="538225"/>
            <a:ext cx="8532440" cy="56359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2254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/>
          <p:cNvSpPr/>
          <p:nvPr/>
        </p:nvSpPr>
        <p:spPr>
          <a:xfrm>
            <a:off x="262936" y="171307"/>
            <a:ext cx="810039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ko-KR" sz="2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NMR Spectrum of GL-3 (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(MeOH-d</a:t>
            </a:r>
            <a:r>
              <a:rPr lang="en-US" altLang="ko-KR" sz="2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900 MHz)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251520" y="5541045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2936" y="692696"/>
            <a:ext cx="8616557" cy="53692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15942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/>
          <p:cNvSpPr/>
          <p:nvPr/>
        </p:nvSpPr>
        <p:spPr>
          <a:xfrm>
            <a:off x="262936" y="171307"/>
            <a:ext cx="810039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altLang="ko-KR" sz="2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 NMR Spectrum of </a:t>
            </a:r>
            <a:r>
              <a:rPr lang="en-US" altLang="ko-K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leonuezhenide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(MeOH-d</a:t>
            </a:r>
            <a:r>
              <a:rPr lang="en-US" altLang="ko-KR" sz="2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900 MHz)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251520" y="5541045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520" y="602257"/>
            <a:ext cx="8577130" cy="57056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16173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/>
          <p:cNvSpPr/>
          <p:nvPr/>
        </p:nvSpPr>
        <p:spPr>
          <a:xfrm>
            <a:off x="262936" y="171307"/>
            <a:ext cx="810039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altLang="ko-KR" sz="2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NMR Spectrum of </a:t>
            </a:r>
            <a:r>
              <a:rPr lang="en-US" altLang="ko-K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leonuezhenide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(MeOH-d</a:t>
            </a:r>
            <a:r>
              <a:rPr lang="en-US" altLang="ko-KR" sz="2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900 MHz)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251520" y="5541045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520" y="590825"/>
            <a:ext cx="8691601" cy="54692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90176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8</TotalTime>
  <Words>68</Words>
  <Application>Microsoft Office PowerPoint</Application>
  <PresentationFormat>On-screen Show (4:3)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맑은 고딕</vt:lpstr>
      <vt:lpstr>Arial</vt:lpstr>
      <vt:lpstr>Times New Roman</vt:lpstr>
      <vt:lpstr>Office 테마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PGK</dc:creator>
  <cp:lastModifiedBy>Fatih Karadeniz</cp:lastModifiedBy>
  <cp:revision>27</cp:revision>
  <dcterms:created xsi:type="dcterms:W3CDTF">2017-05-25T04:59:14Z</dcterms:created>
  <dcterms:modified xsi:type="dcterms:W3CDTF">2019-02-07T03:55:56Z</dcterms:modified>
</cp:coreProperties>
</file>